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24537A-67B9-4BBE-BF96-420C38C5510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3E386F-BB9E-459E-811D-67EF3C4A7C3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F374D5-499E-48B8-8927-B08A83D0ED9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247EA3-BECD-4DC5-BCB7-3F276819B4C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B4B731-DC27-4EA5-B2D6-ADAFA06DF27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338067-940D-4D26-8A7A-65F0CAD0254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13EFC2-0B2F-4DEC-BF29-7E1C7428F3E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B3F6C5-57BA-4D03-9F0C-3776AAD7AB9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ABFC66-01C9-47C7-89AE-A7DF38B626A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7C1C02-65F9-45A9-AEEA-4A9DB975B7E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054184-E435-4D76-B2F7-E12880A9EF3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699D35-D7DA-4980-A285-7719CE11E01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9A984E2-B5A0-4072-804E-D098D17645D4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154080" y="1600200"/>
            <a:ext cx="6504480" cy="4572000"/>
            <a:chOff x="154080" y="1600200"/>
            <a:chExt cx="6504480" cy="4572000"/>
          </a:xfrm>
        </p:grpSpPr>
        <p:pic>
          <p:nvPicPr>
            <p:cNvPr id="42" name="" descr=""/>
            <p:cNvPicPr/>
            <p:nvPr/>
          </p:nvPicPr>
          <p:blipFill>
            <a:blip r:embed="rId1"/>
            <a:stretch/>
          </p:blipFill>
          <p:spPr>
            <a:xfrm>
              <a:off x="228600" y="1676520"/>
              <a:ext cx="2133720" cy="22096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3" name="" descr=""/>
            <p:cNvPicPr/>
            <p:nvPr/>
          </p:nvPicPr>
          <p:blipFill>
            <a:blip r:embed="rId2"/>
            <a:stretch/>
          </p:blipFill>
          <p:spPr>
            <a:xfrm>
              <a:off x="2438280" y="1676520"/>
              <a:ext cx="2057400" cy="22096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4" name="" descr=""/>
            <p:cNvPicPr/>
            <p:nvPr/>
          </p:nvPicPr>
          <p:blipFill>
            <a:blip r:embed="rId3"/>
            <a:stretch/>
          </p:blipFill>
          <p:spPr>
            <a:xfrm>
              <a:off x="4572000" y="1676520"/>
              <a:ext cx="2057400" cy="22096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5" name="" descr=""/>
            <p:cNvPicPr/>
            <p:nvPr/>
          </p:nvPicPr>
          <p:blipFill>
            <a:blip r:embed="rId4"/>
            <a:stretch/>
          </p:blipFill>
          <p:spPr>
            <a:xfrm>
              <a:off x="2438280" y="3962520"/>
              <a:ext cx="2057400" cy="22096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6" name="" descr=""/>
            <p:cNvPicPr/>
            <p:nvPr/>
          </p:nvPicPr>
          <p:blipFill>
            <a:blip r:embed="rId5"/>
            <a:stretch/>
          </p:blipFill>
          <p:spPr>
            <a:xfrm>
              <a:off x="196920" y="3962520"/>
              <a:ext cx="2165400" cy="22096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7" name="" descr=""/>
            <p:cNvPicPr/>
            <p:nvPr/>
          </p:nvPicPr>
          <p:blipFill>
            <a:blip r:embed="rId6"/>
            <a:stretch/>
          </p:blipFill>
          <p:spPr>
            <a:xfrm>
              <a:off x="4572000" y="3962520"/>
              <a:ext cx="2057400" cy="22096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8" name=""/>
            <p:cNvSpPr/>
            <p:nvPr/>
          </p:nvSpPr>
          <p:spPr>
            <a:xfrm>
              <a:off x="1523880" y="6019920"/>
              <a:ext cx="762120" cy="0"/>
            </a:xfrm>
            <a:prstGeom prst="line">
              <a:avLst/>
            </a:prstGeom>
            <a:ln w="5724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1523880" y="3810240"/>
              <a:ext cx="762120" cy="0"/>
            </a:xfrm>
            <a:prstGeom prst="line">
              <a:avLst/>
            </a:prstGeom>
            <a:ln w="5724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1753920" y="1752840"/>
              <a:ext cx="6652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ffffff"/>
                  </a:solidFill>
                  <a:latin typeface="Arial"/>
                </a:rPr>
                <a:t>EGFP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1454400" y="3959280"/>
              <a:ext cx="9075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ffffff"/>
                  </a:solidFill>
                  <a:latin typeface="Arial"/>
                </a:rPr>
                <a:t>Hsp90</a:t>
              </a:r>
              <a:r>
                <a:rPr b="0" lang="en-US" sz="1400" spc="-1" strike="noStrike">
                  <a:solidFill>
                    <a:srgbClr val="ffffff"/>
                  </a:solidFill>
                  <a:latin typeface="Symbol"/>
                  <a:ea typeface="Symbol"/>
                </a:rPr>
                <a:t></a:t>
              </a:r>
              <a:r>
                <a:rPr b="0" lang="en-US" sz="1400" spc="-1" strike="noStrike">
                  <a:solidFill>
                    <a:srgbClr val="ffffff"/>
                  </a:solidFill>
                  <a:latin typeface="Arial"/>
                </a:rPr>
                <a:t>1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3745800" y="1676520"/>
              <a:ext cx="8254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ffffff"/>
                  </a:solidFill>
                  <a:latin typeface="Arial"/>
                </a:rPr>
                <a:t>myosin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3745800" y="3930840"/>
              <a:ext cx="8254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ffffff"/>
                  </a:solidFill>
                  <a:latin typeface="Arial"/>
                </a:rPr>
                <a:t>myosin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5868360" y="1676520"/>
              <a:ext cx="7902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ffffff"/>
                  </a:solidFill>
                  <a:latin typeface="Arial"/>
                </a:rPr>
                <a:t>double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5868360" y="3962520"/>
              <a:ext cx="7902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ffffff"/>
                  </a:solidFill>
                  <a:latin typeface="Arial"/>
                </a:rPr>
                <a:t>double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154440" y="1600200"/>
              <a:ext cx="436680" cy="520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800" spc="-1" strike="noStrike">
                  <a:solidFill>
                    <a:srgbClr val="ffffff"/>
                  </a:solidFill>
                  <a:latin typeface="Arial"/>
                </a:rPr>
                <a:t>B</a:t>
              </a:r>
              <a:endParaRPr b="0" lang="en-US" sz="2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2364480" y="1600200"/>
              <a:ext cx="436680" cy="520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800" spc="-1" strike="noStrike">
                  <a:solidFill>
                    <a:srgbClr val="ffffff"/>
                  </a:solidFill>
                  <a:latin typeface="Arial"/>
                </a:rPr>
                <a:t>C</a:t>
              </a:r>
              <a:endParaRPr b="0" lang="en-US" sz="2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4497840" y="1600200"/>
              <a:ext cx="436680" cy="520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800" spc="-1" strike="noStrike">
                  <a:solidFill>
                    <a:srgbClr val="ffffff"/>
                  </a:solidFill>
                  <a:latin typeface="Arial"/>
                </a:rPr>
                <a:t>D</a:t>
              </a:r>
              <a:endParaRPr b="0" lang="en-US" sz="2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154080" y="3886200"/>
              <a:ext cx="416880" cy="520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800" spc="-1" strike="noStrike">
                  <a:solidFill>
                    <a:srgbClr val="ffffff"/>
                  </a:solidFill>
                  <a:latin typeface="Arial"/>
                </a:rPr>
                <a:t>E</a:t>
              </a:r>
              <a:endParaRPr b="0" lang="en-US" sz="2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2364480" y="3886200"/>
              <a:ext cx="397080" cy="520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800" spc="-1" strike="noStrike">
                  <a:solidFill>
                    <a:srgbClr val="ffffff"/>
                  </a:solidFill>
                  <a:latin typeface="Arial"/>
                </a:rPr>
                <a:t>F</a:t>
              </a:r>
              <a:endParaRPr b="0" lang="en-US" sz="2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4497480" y="3900600"/>
              <a:ext cx="456480" cy="520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800" spc="-1" strike="noStrike">
                  <a:solidFill>
                    <a:srgbClr val="ffffff"/>
                  </a:solidFill>
                  <a:latin typeface="Arial"/>
                </a:rPr>
                <a:t>G</a:t>
              </a:r>
              <a:endParaRPr b="0" lang="en-US" sz="2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457200" y="2819520"/>
              <a:ext cx="0" cy="304920"/>
            </a:xfrm>
            <a:prstGeom prst="line">
              <a:avLst/>
            </a:prstGeom>
            <a:ln w="57240">
              <a:solidFill>
                <a:srgbClr val="ffffff"/>
              </a:solidFill>
              <a:miter/>
              <a:head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2819520" y="2819520"/>
              <a:ext cx="0" cy="304920"/>
            </a:xfrm>
            <a:prstGeom prst="line">
              <a:avLst/>
            </a:prstGeom>
            <a:ln w="57240">
              <a:solidFill>
                <a:srgbClr val="ffffff"/>
              </a:solidFill>
              <a:miter/>
              <a:head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4876920" y="2819520"/>
              <a:ext cx="0" cy="304920"/>
            </a:xfrm>
            <a:prstGeom prst="line">
              <a:avLst/>
            </a:prstGeom>
            <a:ln w="57240">
              <a:solidFill>
                <a:srgbClr val="ffffff"/>
              </a:solidFill>
              <a:miter/>
              <a:head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1828800" y="4496040"/>
              <a:ext cx="0" cy="304560"/>
            </a:xfrm>
            <a:prstGeom prst="line">
              <a:avLst/>
            </a:prstGeom>
            <a:ln w="57240">
              <a:solidFill>
                <a:srgbClr val="ffffff"/>
              </a:solidFill>
              <a:miter/>
              <a:head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6019920" y="4496040"/>
              <a:ext cx="0" cy="304560"/>
            </a:xfrm>
            <a:prstGeom prst="line">
              <a:avLst/>
            </a:prstGeom>
            <a:ln w="57240">
              <a:solidFill>
                <a:srgbClr val="ffffff"/>
              </a:solidFill>
              <a:miter/>
              <a:head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3962520" y="4496040"/>
              <a:ext cx="0" cy="304560"/>
            </a:xfrm>
            <a:prstGeom prst="line">
              <a:avLst/>
            </a:prstGeom>
            <a:ln w="57240">
              <a:solidFill>
                <a:srgbClr val="ffffff"/>
              </a:solidFill>
              <a:miter/>
              <a:head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8" name=""/>
          <p:cNvGrpSpPr/>
          <p:nvPr/>
        </p:nvGrpSpPr>
        <p:grpSpPr>
          <a:xfrm>
            <a:off x="214920" y="152280"/>
            <a:ext cx="6109560" cy="1324080"/>
            <a:chOff x="214920" y="152280"/>
            <a:chExt cx="6109560" cy="1324080"/>
          </a:xfrm>
        </p:grpSpPr>
        <p:sp>
          <p:nvSpPr>
            <p:cNvPr id="69" name=""/>
            <p:cNvSpPr/>
            <p:nvPr/>
          </p:nvSpPr>
          <p:spPr>
            <a:xfrm>
              <a:off x="458640" y="604800"/>
              <a:ext cx="854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</a:rPr>
                <a:t>Smyd1:egfp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214920" y="152280"/>
              <a:ext cx="436680" cy="520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2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71" name=""/>
            <p:cNvGrpSpPr/>
            <p:nvPr/>
          </p:nvGrpSpPr>
          <p:grpSpPr>
            <a:xfrm>
              <a:off x="1668600" y="392040"/>
              <a:ext cx="4655880" cy="380880"/>
              <a:chOff x="1668600" y="392040"/>
              <a:chExt cx="4655880" cy="380880"/>
            </a:xfrm>
          </p:grpSpPr>
          <p:sp>
            <p:nvSpPr>
              <p:cNvPr id="72" name=""/>
              <p:cNvSpPr/>
              <p:nvPr/>
            </p:nvSpPr>
            <p:spPr>
              <a:xfrm>
                <a:off x="1668600" y="680760"/>
                <a:ext cx="1676160" cy="0"/>
              </a:xfrm>
              <a:prstGeom prst="line">
                <a:avLst/>
              </a:prstGeom>
              <a:ln w="57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"/>
              <p:cNvSpPr/>
              <p:nvPr/>
            </p:nvSpPr>
            <p:spPr>
              <a:xfrm>
                <a:off x="5486400" y="680760"/>
                <a:ext cx="8380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"/>
              <p:cNvSpPr/>
              <p:nvPr/>
            </p:nvSpPr>
            <p:spPr>
              <a:xfrm>
                <a:off x="5453280" y="392040"/>
                <a:ext cx="4885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SV4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"/>
              <p:cNvSpPr/>
              <p:nvPr/>
            </p:nvSpPr>
            <p:spPr>
              <a:xfrm>
                <a:off x="5638680" y="604800"/>
                <a:ext cx="152640" cy="15228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"/>
              <p:cNvSpPr/>
              <p:nvPr/>
            </p:nvSpPr>
            <p:spPr>
              <a:xfrm>
                <a:off x="1899000" y="392040"/>
                <a:ext cx="11149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000000"/>
                    </a:solidFill>
                    <a:latin typeface="Arial"/>
                  </a:rPr>
                  <a:t>Smyd1 promoter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" name=""/>
              <p:cNvSpPr/>
              <p:nvPr/>
            </p:nvSpPr>
            <p:spPr>
              <a:xfrm>
                <a:off x="3276720" y="544320"/>
                <a:ext cx="2209680" cy="228600"/>
              </a:xfrm>
              <a:prstGeom prst="rect">
                <a:avLst/>
              </a:prstGeom>
              <a:solidFill>
                <a:srgbClr val="99cc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EGFP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78" name=""/>
            <p:cNvSpPr/>
            <p:nvPr/>
          </p:nvSpPr>
          <p:spPr>
            <a:xfrm>
              <a:off x="1668600" y="1366560"/>
              <a:ext cx="1676160" cy="0"/>
            </a:xfrm>
            <a:prstGeom prst="line">
              <a:avLst/>
            </a:prstGeom>
            <a:ln w="57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5486400" y="1366560"/>
              <a:ext cx="8380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5681880" y="1077840"/>
              <a:ext cx="488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SV4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5867280" y="1290600"/>
              <a:ext cx="152640" cy="15228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1899000" y="1077840"/>
              <a:ext cx="1114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</a:rPr>
                <a:t>Smyd1 promoter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3505320" y="1230120"/>
              <a:ext cx="2209680" cy="228600"/>
            </a:xfrm>
            <a:prstGeom prst="rect">
              <a:avLst/>
            </a:prstGeom>
            <a:solidFill>
              <a:srgbClr val="66663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Hsp90</a:t>
              </a:r>
              <a:r>
                <a:rPr b="0" lang="en-US" sz="18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</a:t>
              </a: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3276720" y="1230120"/>
              <a:ext cx="228600" cy="228600"/>
            </a:xfrm>
            <a:prstGeom prst="rect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3165480" y="1001520"/>
              <a:ext cx="414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myc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423720" y="1230120"/>
              <a:ext cx="1236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</a:rPr>
                <a:t>Smyd1:hsp90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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r>
                <a:rPr b="0" i="1" lang="en-US" sz="1000" spc="-1" strike="noStrike" baseline="30000">
                  <a:solidFill>
                    <a:srgbClr val="000000"/>
                  </a:solidFill>
                  <a:latin typeface="Arial"/>
                </a:rPr>
                <a:t>myc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1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9-02T13:43:06Z</dcterms:created>
  <dc:creator>du</dc:creator>
  <dc:description/>
  <dc:language>en-US</dc:language>
  <cp:lastModifiedBy>du</cp:lastModifiedBy>
  <dcterms:modified xsi:type="dcterms:W3CDTF">2010-09-13T20:41:36Z</dcterms:modified>
  <cp:revision>39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